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307" r:id="rId3"/>
    <p:sldId id="308" r:id="rId4"/>
    <p:sldId id="309" r:id="rId5"/>
    <p:sldId id="259" r:id="rId6"/>
    <p:sldId id="267" r:id="rId7"/>
    <p:sldId id="312" r:id="rId8"/>
    <p:sldId id="314" r:id="rId9"/>
    <p:sldId id="316" r:id="rId10"/>
    <p:sldId id="317" r:id="rId11"/>
    <p:sldId id="318" r:id="rId12"/>
    <p:sldId id="320" r:id="rId13"/>
    <p:sldId id="322" r:id="rId14"/>
    <p:sldId id="324" r:id="rId15"/>
    <p:sldId id="319" r:id="rId16"/>
    <p:sldId id="325" r:id="rId17"/>
    <p:sldId id="327" r:id="rId18"/>
    <p:sldId id="329" r:id="rId19"/>
    <p:sldId id="331" r:id="rId20"/>
    <p:sldId id="326" r:id="rId21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5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6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866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0075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1818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655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825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1673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985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3279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7007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701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5755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9AAC8D-5E44-48F9-B640-0B9C0B294AAB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0200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microsoft.com/office/2007/relationships/hdphoto" Target="../media/hdphoto5.wdp"/><Relationship Id="rId4" Type="http://schemas.openxmlformats.org/officeDocument/2006/relationships/image" Target="../media/image14.png"/><Relationship Id="rId9" Type="http://schemas.microsoft.com/office/2007/relationships/hdphoto" Target="../media/hdphoto7.wdp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microsoft.com/office/2007/relationships/hdphoto" Target="../media/hdphoto8.wdp"/><Relationship Id="rId7" Type="http://schemas.microsoft.com/office/2007/relationships/hdphoto" Target="../media/hdphoto10.wdp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microsoft.com/office/2007/relationships/hdphoto" Target="../media/hdphoto9.wdp"/><Relationship Id="rId4" Type="http://schemas.openxmlformats.org/officeDocument/2006/relationships/image" Target="../media/image22.png"/><Relationship Id="rId9" Type="http://schemas.microsoft.com/office/2007/relationships/hdphoto" Target="../media/hdphoto11.wdp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microsoft.com/office/2007/relationships/hdphoto" Target="../media/hdphoto12.wdp"/><Relationship Id="rId7" Type="http://schemas.microsoft.com/office/2007/relationships/hdphoto" Target="../media/hdphoto14.wdp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microsoft.com/office/2007/relationships/hdphoto" Target="../media/hdphoto13.wdp"/><Relationship Id="rId4" Type="http://schemas.openxmlformats.org/officeDocument/2006/relationships/image" Target="../media/image30.png"/><Relationship Id="rId9" Type="http://schemas.microsoft.com/office/2007/relationships/hdphoto" Target="../media/hdphoto15.wd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6.png"/><Relationship Id="rId7" Type="http://schemas.openxmlformats.org/officeDocument/2006/relationships/image" Target="../media/image8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7.png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0AE742CE-E3DD-49DC-AA75-5E53C19194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592317">
            <a:off x="4210730" y="754062"/>
            <a:ext cx="4410075" cy="44100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AC05BCE-5DE7-1FF0-6F80-CAC2F1E57600}"/>
              </a:ext>
            </a:extLst>
          </p:cNvPr>
          <p:cNvSpPr txBox="1"/>
          <p:nvPr/>
        </p:nvSpPr>
        <p:spPr>
          <a:xfrm>
            <a:off x="0" y="0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-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86232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C1BD006C-4BCB-4DB6-9A4E-CFD8517A9B9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8012" y="1800226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03156" y="123087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67049" y="123087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201894" y="1230872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ldH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441514" y="1916117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8CF6C3D-5863-4CEA-B56E-EFDDD5AE2135}"/>
              </a:ext>
            </a:extLst>
          </p:cNvPr>
          <p:cNvSpPr txBox="1"/>
          <p:nvPr/>
        </p:nvSpPr>
        <p:spPr>
          <a:xfrm>
            <a:off x="7196808" y="123087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8BD9F63F-28D4-416E-A1B1-AD65A5D50B7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041905" y="1800226"/>
            <a:ext cx="2714625" cy="1628775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A170D85C-669E-4491-979E-E6737E6F765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83419" y="1800225"/>
            <a:ext cx="2714625" cy="1628775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E6A297CE-3F25-4E8A-82C9-8C32CC3522C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162660" y="1800225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415456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4A94B236-0F16-48DD-81B4-6AE31F8357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578024">
            <a:off x="4324350" y="929601"/>
            <a:ext cx="4381500" cy="4381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11100B-EBCD-5B9B-C51B-025D67171A1E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831888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CBBF51BE-64D0-4D93-A5D1-21B6A4917F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578024">
            <a:off x="4324350" y="929601"/>
            <a:ext cx="4381500" cy="4381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538219-E39E-21C0-9B04-7AFF97F2B107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982270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F6B5D137-DC06-4AF7-A9A9-1B201CF824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578024">
            <a:off x="4324350" y="929601"/>
            <a:ext cx="4381500" cy="4381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E1D78ED-19E7-64B0-8A9E-3639AEA68A1A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397118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59AE21F4-7FE1-43B7-9755-CEA0F739AD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578024">
            <a:off x="4324350" y="929601"/>
            <a:ext cx="4381500" cy="4381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3511264-1496-4BAB-96E1-7F95F35C7971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066985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EF6CF435-14A1-49FA-9E06-ABE4089832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5756" y="1800225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03156" y="123087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67049" y="123087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43076" y="1230870"/>
            <a:ext cx="159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Neurogenin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441514" y="1916117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8CF6C3D-5863-4CEA-B56E-EFDDD5AE2135}"/>
              </a:ext>
            </a:extLst>
          </p:cNvPr>
          <p:cNvSpPr txBox="1"/>
          <p:nvPr/>
        </p:nvSpPr>
        <p:spPr>
          <a:xfrm>
            <a:off x="7196808" y="123087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A4759213-B973-42EF-9162-D6CA6B6BD7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070323" y="1800225"/>
            <a:ext cx="2714625" cy="1628775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BFCB2582-0543-46D2-903C-3C8D17E61EE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69208" y="1800225"/>
            <a:ext cx="2714625" cy="1628775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19DB15D0-BBB8-426C-B2A5-2D6BD4D874F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162660" y="1803404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83800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E23B2142-0810-4EC0-A3AA-44CCF1B3F9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8188">
            <a:off x="4246563" y="798996"/>
            <a:ext cx="4410075" cy="44100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F5970D7-3CA5-D66A-1422-94D77D119A72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556754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85893E9D-67C4-4D3D-85F0-24030566BC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8188">
            <a:off x="4246563" y="798995"/>
            <a:ext cx="4410075" cy="44100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2C12D44-4FFF-293B-62B5-387709A15997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164534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78A8CD99-8123-4E7E-8521-45AFCDC0AA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8188">
            <a:off x="4246563" y="798996"/>
            <a:ext cx="4410075" cy="44100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C0434AE-CCE0-5AB5-553D-D7B50DF28E48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039738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F69BCE37-EDF3-4459-8B8F-A0973AAA07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8188">
            <a:off x="4246563" y="798995"/>
            <a:ext cx="4410075" cy="44100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4AAEF33-07EF-BE54-40C6-E2FDD4721131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14857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FB438629-442D-4625-A25A-7037464819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580138">
            <a:off x="4210364" y="754429"/>
            <a:ext cx="4410075" cy="44100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696529A-7AC1-AE36-3716-B1071EC31BBC}"/>
              </a:ext>
            </a:extLst>
          </p:cNvPr>
          <p:cNvSpPr txBox="1"/>
          <p:nvPr/>
        </p:nvSpPr>
        <p:spPr>
          <a:xfrm>
            <a:off x="0" y="0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-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89017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23DAD75E-BE69-434E-A21E-923C5C4826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5754" y="1800225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03156" y="123087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67049" y="123087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43076" y="1230870"/>
            <a:ext cx="159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Neurogenin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441514" y="1916117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8CF6C3D-5863-4CEA-B56E-EFDDD5AE2135}"/>
              </a:ext>
            </a:extLst>
          </p:cNvPr>
          <p:cNvSpPr txBox="1"/>
          <p:nvPr/>
        </p:nvSpPr>
        <p:spPr>
          <a:xfrm>
            <a:off x="7196808" y="123087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81118A38-F6F9-4FEB-93CC-5A4D6E220BC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041905" y="1800225"/>
            <a:ext cx="2714625" cy="1628775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EF182C22-EB1F-4E9F-901E-57746980297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83415" y="1800225"/>
            <a:ext cx="2714625" cy="1628775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FAAD1A17-432F-4E5F-BB39-C963C079C33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162660" y="1816105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42846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C0B17649-A781-497E-9751-E1EB9C1FCD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570243">
            <a:off x="4209307" y="754754"/>
            <a:ext cx="4410075" cy="44100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EE24738-CABC-09F6-D7B0-263645036E93}"/>
              </a:ext>
            </a:extLst>
          </p:cNvPr>
          <p:cNvSpPr txBox="1"/>
          <p:nvPr/>
        </p:nvSpPr>
        <p:spPr>
          <a:xfrm>
            <a:off x="0" y="0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-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42445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2EBC98AB-B8A3-4503-8D29-DB401AC8EE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585567">
            <a:off x="4209306" y="754061"/>
            <a:ext cx="4410075" cy="44100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55B520C-6345-58B6-083C-96807F1129D8}"/>
              </a:ext>
            </a:extLst>
          </p:cNvPr>
          <p:cNvSpPr txBox="1"/>
          <p:nvPr/>
        </p:nvSpPr>
        <p:spPr>
          <a:xfrm>
            <a:off x="0" y="0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-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81576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>
            <a:extLst>
              <a:ext uri="{FF2B5EF4-FFF2-40B4-BE49-F238E27FC236}">
                <a16:creationId xmlns:a16="http://schemas.microsoft.com/office/drawing/2014/main" id="{86708C96-0CCD-41C0-AFBE-6789634F72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014" y="1800226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-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03156" y="123087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67049" y="123087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201894" y="1230872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ldH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441514" y="1916117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그림 8">
            <a:extLst>
              <a:ext uri="{FF2B5EF4-FFF2-40B4-BE49-F238E27FC236}">
                <a16:creationId xmlns:a16="http://schemas.microsoft.com/office/drawing/2014/main" id="{B8036838-DE46-48CE-9A0D-CA540595BCC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054986" y="1800225"/>
            <a:ext cx="2714625" cy="1628775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AB1447F8-4301-4C6F-B4F3-0FBDCE6F163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70338" y="1800227"/>
            <a:ext cx="2714625" cy="1628775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7E63D172-F76A-4D55-947D-D5890F97326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162662" y="1800226"/>
            <a:ext cx="2714625" cy="162877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8CF6C3D-5863-4CEA-B56E-EFDDD5AE2135}"/>
              </a:ext>
            </a:extLst>
          </p:cNvPr>
          <p:cNvSpPr txBox="1"/>
          <p:nvPr/>
        </p:nvSpPr>
        <p:spPr>
          <a:xfrm>
            <a:off x="7196808" y="123087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90489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48584F9F-BFA5-428B-ADA1-B19F486573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492917">
            <a:off x="4334556" y="823458"/>
            <a:ext cx="4391025" cy="439102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9F180DD-A972-F88A-65C1-9677A6D3585F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48872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D7A6075F-35AD-40C3-B50F-C6A9FFE01C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502992">
            <a:off x="4297634" y="826575"/>
            <a:ext cx="4391025" cy="439102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21630CB-738C-9C19-B983-9D4EC7D4FAFD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95580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F7757E36-8C98-4018-B9CD-9D9502530B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483657">
            <a:off x="4331669" y="820571"/>
            <a:ext cx="4391025" cy="439102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13CA652-C4CA-D203-25EB-66D00350D5B3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51976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341C588A-20DA-4AA2-A932-5ECC6CC70B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502992">
            <a:off x="4297634" y="826575"/>
            <a:ext cx="4391025" cy="439102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9FD3FF5-84AF-ACF0-63D8-C9869521808A}"/>
              </a:ext>
            </a:extLst>
          </p:cNvPr>
          <p:cNvSpPr txBox="1"/>
          <p:nvPr/>
        </p:nvSpPr>
        <p:spPr>
          <a:xfrm>
            <a:off x="0" y="0"/>
            <a:ext cx="2024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mKO2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1303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91</Words>
  <Application>Microsoft Office PowerPoint</Application>
  <PresentationFormat>와이드스크린</PresentationFormat>
  <Paragraphs>36</Paragraphs>
  <Slides>2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0</vt:i4>
      </vt:variant>
    </vt:vector>
  </HeadingPairs>
  <TitlesOfParts>
    <vt:vector size="23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이 원영</cp:lastModifiedBy>
  <cp:revision>27</cp:revision>
  <dcterms:created xsi:type="dcterms:W3CDTF">2019-01-29T05:34:41Z</dcterms:created>
  <dcterms:modified xsi:type="dcterms:W3CDTF">2024-09-30T05:40:49Z</dcterms:modified>
</cp:coreProperties>
</file>